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18F7BB-0EAB-4C25-9513-7674929E72C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E5C288-EE3E-4842-A24E-73BAAEF56E2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A1A0D8-A949-42B3-8AD6-D5BE938C367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B5D2F9-BD0D-4E01-809B-9F134AED075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96033C-37BF-4E5D-AC0E-7CE3FBD3956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38C6AE-A82A-4997-974F-29B677928B0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AF619B-DC53-485F-A6DE-7F94795EEFA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F1EB67-2B84-4C18-AD3D-1E6285FE4D7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E88E8E-03D0-4271-9DD4-3F649656104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DE663A-4044-4A25-AB5A-C2060563AF9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795A52-7BDA-401F-B177-CD062853FC5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54F0A9-122D-4BBA-B7F3-3BF6D5C032F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D891846-1E7B-4CE3-93C8-F8751C05E6A6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Chart 3" descr=""/>
          <p:cNvPicPr/>
          <p:nvPr/>
        </p:nvPicPr>
        <p:blipFill>
          <a:blip r:embed="rId1"/>
          <a:stretch/>
        </p:blipFill>
        <p:spPr>
          <a:xfrm>
            <a:off x="2004840" y="1895400"/>
            <a:ext cx="5134320" cy="3067200"/>
          </a:xfrm>
          <a:prstGeom prst="rect">
            <a:avLst/>
          </a:prstGeom>
          <a:ln w="0">
            <a:noFill/>
          </a:ln>
        </p:spPr>
      </p:pic>
      <p:sp>
        <p:nvSpPr>
          <p:cNvPr id="42" name="TextBox 4"/>
          <p:cNvSpPr/>
          <p:nvPr/>
        </p:nvSpPr>
        <p:spPr>
          <a:xfrm>
            <a:off x="762120" y="533520"/>
            <a:ext cx="183960" cy="36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 Box 912"/>
          <p:cNvSpPr/>
          <p:nvPr/>
        </p:nvSpPr>
        <p:spPr>
          <a:xfrm>
            <a:off x="1295280" y="349200"/>
            <a:ext cx="6324840" cy="94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upplementary Figure S7. Reactivity of anti-human IgG with human IgG and human IgM. PBST, Phosphate-buffered saline buffer containing 0.05% Tween-20 was used as a negative control. The preparation of anti-human IgG does not recognize human IgM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Rectangle 6"/>
          <p:cNvSpPr/>
          <p:nvPr/>
        </p:nvSpPr>
        <p:spPr>
          <a:xfrm>
            <a:off x="1905120" y="1676520"/>
            <a:ext cx="5333760" cy="335268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8-11T22:16:12Z</dcterms:created>
  <dc:creator>IT</dc:creator>
  <dc:description/>
  <dc:language>en-US</dc:language>
  <cp:lastModifiedBy>IT</cp:lastModifiedBy>
  <dcterms:modified xsi:type="dcterms:W3CDTF">2012-01-03T21:39:23Z</dcterms:modified>
  <cp:revision>3</cp:revision>
  <dc:subject/>
  <dc:title>PowerPoint Presentation</dc:title>
</cp:coreProperties>
</file>